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5040313" cy="3240088"/>
  <p:notesSz cx="6858000" cy="9144000"/>
  <p:defaultTextStyle>
    <a:defPPr>
      <a:defRPr lang="zh-CN"/>
    </a:defPPr>
    <a:lvl1pPr marL="0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1pPr>
    <a:lvl2pPr marL="152854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2pPr>
    <a:lvl3pPr marL="305706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3pPr>
    <a:lvl4pPr marL="458559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4pPr>
    <a:lvl5pPr marL="611412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5pPr>
    <a:lvl6pPr marL="764265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6pPr>
    <a:lvl7pPr marL="917118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7pPr>
    <a:lvl8pPr marL="1069971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8pPr>
    <a:lvl9pPr marL="1222824" algn="l" defTabSz="305706" rtl="0" eaLnBrk="1" latinLnBrk="0" hangingPunct="1">
      <a:defRPr sz="60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15" userDrawn="1">
          <p15:clr>
            <a:srgbClr val="A4A3A4"/>
          </p15:clr>
        </p15:guide>
        <p15:guide id="2" pos="615" userDrawn="1">
          <p15:clr>
            <a:srgbClr val="A4A3A4"/>
          </p15:clr>
        </p15:guide>
        <p15:guide id="3" pos="1846" userDrawn="1">
          <p15:clr>
            <a:srgbClr val="A4A3A4"/>
          </p15:clr>
        </p15:guide>
        <p15:guide id="4" orient="horz" pos="16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53"/>
    <p:restoredTop sz="95242"/>
  </p:normalViewPr>
  <p:slideViewPr>
    <p:cSldViewPr snapToGrid="0" snapToObjects="1" showGuides="1">
      <p:cViewPr>
        <p:scale>
          <a:sx n="174" d="100"/>
          <a:sy n="174" d="100"/>
        </p:scale>
        <p:origin x="1616" y="336"/>
      </p:cViewPr>
      <p:guideLst>
        <p:guide orient="horz" pos="715"/>
        <p:guide pos="615"/>
        <p:guide pos="1846"/>
        <p:guide orient="horz" pos="16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localhost/Users/lxmpro/Documents/RcodeLXM/180130/850K.island.gap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localhost/Users/lxmpro/Documents/RcodeLXM/180130/850K.island.gap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lxmpro/Documents/RcodeLXM/180130/H1-hESC_array_450K/450K.island.gap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localhost/Users/lxmpro/Documents/RcodeLXM/180130/H1-hESC_array_450K/450K.island.gap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783544914029"/>
          <c:y val="0.0875420875420875"/>
          <c:w val="0.622259762172586"/>
          <c:h val="0.6282445851538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450K.island.gap'!$A$2</c:f>
              <c:strCache>
                <c:ptCount val="1"/>
                <c:pt idx="0">
                  <c:v>Fraction</c:v>
                </c:pt>
              </c:strCache>
            </c:strRef>
          </c:tx>
          <c:spPr>
            <a:solidFill>
              <a:srgbClr val="1545AD"/>
            </a:solidFill>
            <a:ln w="3175">
              <a:solidFill>
                <a:schemeClr val="bg1">
                  <a:lumMod val="85000"/>
                  <a:alpha val="50000"/>
                </a:schemeClr>
              </a:solidFill>
              <a:prstDash val="solid"/>
            </a:ln>
            <a:effectLst/>
          </c:spPr>
          <c:invertIfNegative val="0"/>
          <c:cat>
            <c:numRef>
              <c:f>'450K.island.gap'!$B$1:$AO$1</c:f>
              <c:numCache>
                <c:formatCode>General</c:formatCode>
                <c:ptCount val="40"/>
                <c:pt idx="0">
                  <c:v>0.0</c:v>
                </c:pt>
                <c:pt idx="1">
                  <c:v>600.0</c:v>
                </c:pt>
                <c:pt idx="2">
                  <c:v>900.0</c:v>
                </c:pt>
                <c:pt idx="3">
                  <c:v>1200.0</c:v>
                </c:pt>
                <c:pt idx="4">
                  <c:v>1500.0</c:v>
                </c:pt>
                <c:pt idx="5">
                  <c:v>1800.0</c:v>
                </c:pt>
                <c:pt idx="6">
                  <c:v>2100.0</c:v>
                </c:pt>
                <c:pt idx="7">
                  <c:v>2400.0</c:v>
                </c:pt>
                <c:pt idx="8">
                  <c:v>2700.0</c:v>
                </c:pt>
                <c:pt idx="9">
                  <c:v>3000.0</c:v>
                </c:pt>
                <c:pt idx="10">
                  <c:v>3000.0</c:v>
                </c:pt>
                <c:pt idx="11">
                  <c:v>3600.0</c:v>
                </c:pt>
                <c:pt idx="12">
                  <c:v>3900.0</c:v>
                </c:pt>
                <c:pt idx="13">
                  <c:v>4200.0</c:v>
                </c:pt>
                <c:pt idx="14">
                  <c:v>4500.0</c:v>
                </c:pt>
                <c:pt idx="15">
                  <c:v>4800.0</c:v>
                </c:pt>
                <c:pt idx="16">
                  <c:v>5100.0</c:v>
                </c:pt>
                <c:pt idx="17">
                  <c:v>5400.0</c:v>
                </c:pt>
                <c:pt idx="18">
                  <c:v>5700.0</c:v>
                </c:pt>
                <c:pt idx="19">
                  <c:v>6000.0</c:v>
                </c:pt>
                <c:pt idx="20">
                  <c:v>6000.0</c:v>
                </c:pt>
                <c:pt idx="21">
                  <c:v>6600.0</c:v>
                </c:pt>
                <c:pt idx="22">
                  <c:v>6900.0</c:v>
                </c:pt>
                <c:pt idx="23">
                  <c:v>7200.0</c:v>
                </c:pt>
                <c:pt idx="24">
                  <c:v>7500.0</c:v>
                </c:pt>
                <c:pt idx="25">
                  <c:v>7800.0</c:v>
                </c:pt>
                <c:pt idx="26">
                  <c:v>8100.0</c:v>
                </c:pt>
                <c:pt idx="27">
                  <c:v>8400.0</c:v>
                </c:pt>
                <c:pt idx="28">
                  <c:v>8700.0</c:v>
                </c:pt>
                <c:pt idx="29">
                  <c:v>9000.0</c:v>
                </c:pt>
                <c:pt idx="30">
                  <c:v>9000.0</c:v>
                </c:pt>
                <c:pt idx="31">
                  <c:v>9600.0</c:v>
                </c:pt>
                <c:pt idx="32">
                  <c:v>9900.0</c:v>
                </c:pt>
                <c:pt idx="33">
                  <c:v>10200.0</c:v>
                </c:pt>
                <c:pt idx="34">
                  <c:v>10500.0</c:v>
                </c:pt>
                <c:pt idx="35">
                  <c:v>10800.0</c:v>
                </c:pt>
                <c:pt idx="36">
                  <c:v>11100.0</c:v>
                </c:pt>
                <c:pt idx="37">
                  <c:v>11400.0</c:v>
                </c:pt>
                <c:pt idx="38">
                  <c:v>11700.0</c:v>
                </c:pt>
                <c:pt idx="39">
                  <c:v>12000.0</c:v>
                </c:pt>
              </c:numCache>
            </c:numRef>
          </c:cat>
          <c:val>
            <c:numRef>
              <c:f>'450K.island.gap'!$B$2:$AO$2</c:f>
              <c:numCache>
                <c:formatCode>General</c:formatCode>
                <c:ptCount val="40"/>
                <c:pt idx="0">
                  <c:v>0.277665361759156</c:v>
                </c:pt>
                <c:pt idx="1">
                  <c:v>0.108073674372675</c:v>
                </c:pt>
                <c:pt idx="2">
                  <c:v>0.0745913347087764</c:v>
                </c:pt>
                <c:pt idx="3">
                  <c:v>0.0574666278721191</c:v>
                </c:pt>
                <c:pt idx="4">
                  <c:v>0.044620342450052</c:v>
                </c:pt>
                <c:pt idx="5">
                  <c:v>0.0368768625791321</c:v>
                </c:pt>
                <c:pt idx="6">
                  <c:v>0.032682202119593</c:v>
                </c:pt>
                <c:pt idx="7">
                  <c:v>0.0290496217531609</c:v>
                </c:pt>
                <c:pt idx="8">
                  <c:v>0.026164277275212</c:v>
                </c:pt>
                <c:pt idx="9">
                  <c:v>0.023349468338359</c:v>
                </c:pt>
                <c:pt idx="10">
                  <c:v>0.020653688127105</c:v>
                </c:pt>
                <c:pt idx="11">
                  <c:v>0.0189850817330582</c:v>
                </c:pt>
                <c:pt idx="12">
                  <c:v>0.0171621788428644</c:v>
                </c:pt>
                <c:pt idx="13">
                  <c:v>0.0157867357914969</c:v>
                </c:pt>
                <c:pt idx="14">
                  <c:v>0.014389250383537</c:v>
                </c:pt>
                <c:pt idx="15">
                  <c:v>0.0134171824578109</c:v>
                </c:pt>
                <c:pt idx="16">
                  <c:v>0.0127074185755347</c:v>
                </c:pt>
                <c:pt idx="17">
                  <c:v>0.0117816395986528</c:v>
                </c:pt>
                <c:pt idx="18">
                  <c:v>0.0110476291241249</c:v>
                </c:pt>
                <c:pt idx="19">
                  <c:v>0.0103885626620113</c:v>
                </c:pt>
                <c:pt idx="20">
                  <c:v>0.00988158846038548</c:v>
                </c:pt>
                <c:pt idx="21">
                  <c:v>0.00890731629900016</c:v>
                </c:pt>
                <c:pt idx="22">
                  <c:v>0.00844663104621841</c:v>
                </c:pt>
                <c:pt idx="23">
                  <c:v>0.00817110158881306</c:v>
                </c:pt>
                <c:pt idx="24">
                  <c:v>0.00731144968170837</c:v>
                </c:pt>
                <c:pt idx="25">
                  <c:v>0.00689925761342997</c:v>
                </c:pt>
                <c:pt idx="26">
                  <c:v>0.00674275688162373</c:v>
                </c:pt>
                <c:pt idx="27">
                  <c:v>0.00625121232961258</c:v>
                </c:pt>
                <c:pt idx="28">
                  <c:v>0.00582799908303797</c:v>
                </c:pt>
                <c:pt idx="29">
                  <c:v>0.00556569503958807</c:v>
                </c:pt>
                <c:pt idx="30">
                  <c:v>0.00507855895889541</c:v>
                </c:pt>
                <c:pt idx="31">
                  <c:v>0.00480743797280855</c:v>
                </c:pt>
                <c:pt idx="32">
                  <c:v>0.00452529580842547</c:v>
                </c:pt>
                <c:pt idx="33">
                  <c:v>0.00442169673244106</c:v>
                </c:pt>
                <c:pt idx="34">
                  <c:v>0.00438202049057469</c:v>
                </c:pt>
                <c:pt idx="35">
                  <c:v>0.00419025198822056</c:v>
                </c:pt>
                <c:pt idx="36">
                  <c:v>0.00403154702075508</c:v>
                </c:pt>
                <c:pt idx="37">
                  <c:v>0.00376924297730519</c:v>
                </c:pt>
                <c:pt idx="38">
                  <c:v>0.00357527023929182</c:v>
                </c:pt>
                <c:pt idx="39">
                  <c:v>0.003332804316775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2147098624"/>
        <c:axId val="-2131254512"/>
      </c:barChart>
      <c:catAx>
        <c:axId val="214709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/>
                  <a:t>Gap(bp)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-2131254512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-21312545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/>
                  <a:t>Density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21470986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783544914029"/>
          <c:y val="0.0875420875420875"/>
          <c:w val="0.622259762172586"/>
          <c:h val="0.6282445851538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450K.island.gap'!$A$2</c:f>
              <c:strCache>
                <c:ptCount val="1"/>
                <c:pt idx="0">
                  <c:v>Fraction</c:v>
                </c:pt>
              </c:strCache>
            </c:strRef>
          </c:tx>
          <c:spPr>
            <a:solidFill>
              <a:srgbClr val="1545AD"/>
            </a:solidFill>
            <a:ln w="3175">
              <a:solidFill>
                <a:schemeClr val="bg1">
                  <a:lumMod val="85000"/>
                  <a:alpha val="51000"/>
                </a:schemeClr>
              </a:solidFill>
            </a:ln>
            <a:effectLst/>
          </c:spPr>
          <c:invertIfNegative val="0"/>
          <c:cat>
            <c:numRef>
              <c:f>'450K.island.gap'!$B$3:$AO$3</c:f>
              <c:numCache>
                <c:formatCode>General</c:formatCode>
                <c:ptCount val="40"/>
                <c:pt idx="0">
                  <c:v>0.0</c:v>
                </c:pt>
                <c:pt idx="1">
                  <c:v>200.0</c:v>
                </c:pt>
                <c:pt idx="2">
                  <c:v>300.0</c:v>
                </c:pt>
                <c:pt idx="3">
                  <c:v>400.0</c:v>
                </c:pt>
                <c:pt idx="4">
                  <c:v>500.0</c:v>
                </c:pt>
                <c:pt idx="5">
                  <c:v>600.0</c:v>
                </c:pt>
                <c:pt idx="6">
                  <c:v>700.0</c:v>
                </c:pt>
                <c:pt idx="7">
                  <c:v>800.0</c:v>
                </c:pt>
                <c:pt idx="8">
                  <c:v>900.0</c:v>
                </c:pt>
                <c:pt idx="9">
                  <c:v>1000.0</c:v>
                </c:pt>
                <c:pt idx="10">
                  <c:v>1000.0</c:v>
                </c:pt>
                <c:pt idx="11">
                  <c:v>1200.0</c:v>
                </c:pt>
                <c:pt idx="12">
                  <c:v>1300.0</c:v>
                </c:pt>
                <c:pt idx="13">
                  <c:v>1400.0</c:v>
                </c:pt>
                <c:pt idx="14">
                  <c:v>1500.0</c:v>
                </c:pt>
                <c:pt idx="15">
                  <c:v>1600.0</c:v>
                </c:pt>
                <c:pt idx="16">
                  <c:v>1700.0</c:v>
                </c:pt>
                <c:pt idx="17">
                  <c:v>1800.0</c:v>
                </c:pt>
                <c:pt idx="18">
                  <c:v>1900.0</c:v>
                </c:pt>
                <c:pt idx="19">
                  <c:v>2000.0</c:v>
                </c:pt>
                <c:pt idx="20">
                  <c:v>2000.0</c:v>
                </c:pt>
                <c:pt idx="21">
                  <c:v>2200.0</c:v>
                </c:pt>
                <c:pt idx="22">
                  <c:v>2300.0</c:v>
                </c:pt>
                <c:pt idx="23">
                  <c:v>2400.0</c:v>
                </c:pt>
                <c:pt idx="24">
                  <c:v>2500.0</c:v>
                </c:pt>
                <c:pt idx="25">
                  <c:v>2600.0</c:v>
                </c:pt>
                <c:pt idx="26">
                  <c:v>2700.0</c:v>
                </c:pt>
                <c:pt idx="27">
                  <c:v>2800.0</c:v>
                </c:pt>
                <c:pt idx="28">
                  <c:v>2900.0</c:v>
                </c:pt>
                <c:pt idx="29">
                  <c:v>3000.0</c:v>
                </c:pt>
                <c:pt idx="30">
                  <c:v>3000.0</c:v>
                </c:pt>
                <c:pt idx="31">
                  <c:v>3200.0</c:v>
                </c:pt>
                <c:pt idx="32">
                  <c:v>3300.0</c:v>
                </c:pt>
                <c:pt idx="33">
                  <c:v>3400.0</c:v>
                </c:pt>
                <c:pt idx="34">
                  <c:v>3500.0</c:v>
                </c:pt>
                <c:pt idx="35">
                  <c:v>3600.0</c:v>
                </c:pt>
                <c:pt idx="36">
                  <c:v>3700.0</c:v>
                </c:pt>
                <c:pt idx="37">
                  <c:v>3800.0</c:v>
                </c:pt>
                <c:pt idx="38">
                  <c:v>3900.0</c:v>
                </c:pt>
                <c:pt idx="39">
                  <c:v>4000.0</c:v>
                </c:pt>
              </c:numCache>
            </c:numRef>
          </c:cat>
          <c:val>
            <c:numRef>
              <c:f>'450K.island.gap'!$B$4:$AO$4</c:f>
              <c:numCache>
                <c:formatCode>General</c:formatCode>
                <c:ptCount val="40"/>
                <c:pt idx="0">
                  <c:v>0.459973252157576</c:v>
                </c:pt>
                <c:pt idx="1">
                  <c:v>0.188522092068512</c:v>
                </c:pt>
                <c:pt idx="2">
                  <c:v>0.103947278783511</c:v>
                </c:pt>
                <c:pt idx="3">
                  <c:v>0.0654640894080695</c:v>
                </c:pt>
                <c:pt idx="4">
                  <c:v>0.043008092477259</c:v>
                </c:pt>
                <c:pt idx="5">
                  <c:v>0.0305269611797735</c:v>
                </c:pt>
                <c:pt idx="6">
                  <c:v>0.0217317255943865</c:v>
                </c:pt>
                <c:pt idx="7">
                  <c:v>0.0162136385312351</c:v>
                </c:pt>
                <c:pt idx="8">
                  <c:v>0.012739287417399</c:v>
                </c:pt>
                <c:pt idx="9">
                  <c:v>0.0102150942449113</c:v>
                </c:pt>
                <c:pt idx="10">
                  <c:v>0.00811757577061395</c:v>
                </c:pt>
                <c:pt idx="11">
                  <c:v>0.00714231931760732</c:v>
                </c:pt>
                <c:pt idx="12">
                  <c:v>0.00571528965475204</c:v>
                </c:pt>
                <c:pt idx="13">
                  <c:v>0.0050125313283208</c:v>
                </c:pt>
                <c:pt idx="14">
                  <c:v>0.00414125442361268</c:v>
                </c:pt>
                <c:pt idx="15">
                  <c:v>0.00377911875540066</c:v>
                </c:pt>
                <c:pt idx="16">
                  <c:v>0.00319826748559525</c:v>
                </c:pt>
                <c:pt idx="17">
                  <c:v>0.00278952029573218</c:v>
                </c:pt>
                <c:pt idx="18">
                  <c:v>0.0023090630725598</c:v>
                </c:pt>
                <c:pt idx="19">
                  <c:v>0.00225528054757781</c:v>
                </c:pt>
                <c:pt idx="20">
                  <c:v>0.00143420066618621</c:v>
                </c:pt>
                <c:pt idx="21">
                  <c:v>0.00082466538305707</c:v>
                </c:pt>
                <c:pt idx="22">
                  <c:v>0.000394405183201208</c:v>
                </c:pt>
                <c:pt idx="23">
                  <c:v>0.000215130099927931</c:v>
                </c:pt>
                <c:pt idx="24" formatCode="0.00E+00">
                  <c:v>7.88810366402415E-5</c:v>
                </c:pt>
                <c:pt idx="25" formatCode="0.00E+00">
                  <c:v>4.66115216510518E-5</c:v>
                </c:pt>
                <c:pt idx="26" formatCode="0.00E+00">
                  <c:v>3.58550166546552E-5</c:v>
                </c:pt>
                <c:pt idx="27" formatCode="0.00E+00">
                  <c:v>3.94405183201208E-5</c:v>
                </c:pt>
                <c:pt idx="28" formatCode="0.00E+00">
                  <c:v>2.15130099927931E-5</c:v>
                </c:pt>
                <c:pt idx="29" formatCode="0.00E+00">
                  <c:v>1.07565049963966E-5</c:v>
                </c:pt>
                <c:pt idx="30" formatCode="0.00E+00">
                  <c:v>2.50985116582587E-5</c:v>
                </c:pt>
                <c:pt idx="31" formatCode="0.00E+00">
                  <c:v>1.07565049963966E-5</c:v>
                </c:pt>
                <c:pt idx="32" formatCode="0.00E+00">
                  <c:v>1.79275083273276E-5</c:v>
                </c:pt>
                <c:pt idx="33" formatCode="0.00E+00">
                  <c:v>7.17100333093105E-6</c:v>
                </c:pt>
                <c:pt idx="34" formatCode="0.00E+00">
                  <c:v>3.58550166546552E-6</c:v>
                </c:pt>
                <c:pt idx="35" formatCode="0.00E+00">
                  <c:v>3.58550166546552E-6</c:v>
                </c:pt>
                <c:pt idx="36" formatCode="0.00E+00">
                  <c:v>1.43420066618621E-5</c:v>
                </c:pt>
                <c:pt idx="37" formatCode="0.00E+00">
                  <c:v>3.58550166546552E-6</c:v>
                </c:pt>
                <c:pt idx="38" formatCode="0.00E+00">
                  <c:v>3.58550166546552E-6</c:v>
                </c:pt>
                <c:pt idx="39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-2143903680"/>
        <c:axId val="-2143897648"/>
      </c:barChart>
      <c:catAx>
        <c:axId val="-2143903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/>
                  <a:t>Gap(bp)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-2143897648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-2143897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/>
                  <a:t>Density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-214390368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latin typeface="Arial" charset="0"/>
          <a:ea typeface="Arial" charset="0"/>
          <a:cs typeface="Arial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783544914029"/>
          <c:y val="0.0875420875420875"/>
          <c:w val="0.622259762172586"/>
          <c:h val="0.6282445851538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450K.island.gap'!$A$2</c:f>
              <c:strCache>
                <c:ptCount val="1"/>
                <c:pt idx="0">
                  <c:v>Fraction</c:v>
                </c:pt>
              </c:strCache>
            </c:strRef>
          </c:tx>
          <c:spPr>
            <a:solidFill>
              <a:srgbClr val="1545AD"/>
            </a:solidFill>
            <a:ln w="3175">
              <a:solidFill>
                <a:schemeClr val="bg1">
                  <a:lumMod val="85000"/>
                  <a:alpha val="50000"/>
                </a:schemeClr>
              </a:solidFill>
              <a:prstDash val="solid"/>
            </a:ln>
            <a:effectLst/>
          </c:spPr>
          <c:invertIfNegative val="0"/>
          <c:cat>
            <c:numRef>
              <c:f>'450K.island.gap'!$B$1:$AO$1</c:f>
              <c:numCache>
                <c:formatCode>General</c:formatCode>
                <c:ptCount val="40"/>
                <c:pt idx="0">
                  <c:v>0.0</c:v>
                </c:pt>
                <c:pt idx="1">
                  <c:v>6000.0</c:v>
                </c:pt>
                <c:pt idx="2">
                  <c:v>9000.0</c:v>
                </c:pt>
                <c:pt idx="3">
                  <c:v>12000.0</c:v>
                </c:pt>
                <c:pt idx="4">
                  <c:v>15000.0</c:v>
                </c:pt>
                <c:pt idx="5">
                  <c:v>18000.0</c:v>
                </c:pt>
                <c:pt idx="6">
                  <c:v>21000.0</c:v>
                </c:pt>
                <c:pt idx="7">
                  <c:v>24000.0</c:v>
                </c:pt>
                <c:pt idx="8">
                  <c:v>27000.0</c:v>
                </c:pt>
                <c:pt idx="9">
                  <c:v>30000.0</c:v>
                </c:pt>
                <c:pt idx="10">
                  <c:v>30000.0</c:v>
                </c:pt>
                <c:pt idx="11">
                  <c:v>36000.0</c:v>
                </c:pt>
                <c:pt idx="12">
                  <c:v>39000.0</c:v>
                </c:pt>
                <c:pt idx="13">
                  <c:v>42000.0</c:v>
                </c:pt>
                <c:pt idx="14">
                  <c:v>45000.0</c:v>
                </c:pt>
                <c:pt idx="15">
                  <c:v>48000.0</c:v>
                </c:pt>
                <c:pt idx="16">
                  <c:v>51000.0</c:v>
                </c:pt>
                <c:pt idx="17">
                  <c:v>54000.0</c:v>
                </c:pt>
                <c:pt idx="18">
                  <c:v>57000.0</c:v>
                </c:pt>
                <c:pt idx="19">
                  <c:v>60000.0</c:v>
                </c:pt>
                <c:pt idx="20">
                  <c:v>60000.0</c:v>
                </c:pt>
                <c:pt idx="21">
                  <c:v>66000.0</c:v>
                </c:pt>
                <c:pt idx="22">
                  <c:v>69000.0</c:v>
                </c:pt>
                <c:pt idx="23">
                  <c:v>72000.0</c:v>
                </c:pt>
                <c:pt idx="24">
                  <c:v>75000.0</c:v>
                </c:pt>
                <c:pt idx="25">
                  <c:v>78000.0</c:v>
                </c:pt>
                <c:pt idx="26">
                  <c:v>81000.0</c:v>
                </c:pt>
                <c:pt idx="27">
                  <c:v>84000.0</c:v>
                </c:pt>
                <c:pt idx="28">
                  <c:v>87000.0</c:v>
                </c:pt>
                <c:pt idx="29">
                  <c:v>90000.0</c:v>
                </c:pt>
                <c:pt idx="30">
                  <c:v>90000.0</c:v>
                </c:pt>
                <c:pt idx="31">
                  <c:v>96000.0</c:v>
                </c:pt>
                <c:pt idx="32">
                  <c:v>99000.0</c:v>
                </c:pt>
                <c:pt idx="33">
                  <c:v>102000.0</c:v>
                </c:pt>
                <c:pt idx="34">
                  <c:v>105000.0</c:v>
                </c:pt>
                <c:pt idx="35">
                  <c:v>108000.0</c:v>
                </c:pt>
                <c:pt idx="36">
                  <c:v>111000.0</c:v>
                </c:pt>
                <c:pt idx="37">
                  <c:v>114000.0</c:v>
                </c:pt>
                <c:pt idx="38">
                  <c:v>117000.0</c:v>
                </c:pt>
                <c:pt idx="39">
                  <c:v>120000.0</c:v>
                </c:pt>
              </c:numCache>
            </c:numRef>
          </c:cat>
          <c:val>
            <c:numRef>
              <c:f>'450K.island.gap'!$B$2:$AO$2</c:f>
              <c:numCache>
                <c:formatCode>General</c:formatCode>
                <c:ptCount val="40"/>
                <c:pt idx="0">
                  <c:v>0.535794837</c:v>
                </c:pt>
                <c:pt idx="1">
                  <c:v>0.095121592</c:v>
                </c:pt>
                <c:pt idx="2">
                  <c:v>0.081894786</c:v>
                </c:pt>
                <c:pt idx="3">
                  <c:v>0.053879299</c:v>
                </c:pt>
                <c:pt idx="4">
                  <c:v>0.039292677</c:v>
                </c:pt>
                <c:pt idx="5">
                  <c:v>0.029773965</c:v>
                </c:pt>
                <c:pt idx="6">
                  <c:v>0.023313473</c:v>
                </c:pt>
                <c:pt idx="7">
                  <c:v>0.018556847</c:v>
                </c:pt>
                <c:pt idx="8">
                  <c:v>0.015727993</c:v>
                </c:pt>
                <c:pt idx="9">
                  <c:v>0.012342106</c:v>
                </c:pt>
                <c:pt idx="10">
                  <c:v>0.01117889</c:v>
                </c:pt>
                <c:pt idx="11">
                  <c:v>0.009393107</c:v>
                </c:pt>
                <c:pt idx="12">
                  <c:v>0.007869458</c:v>
                </c:pt>
                <c:pt idx="13">
                  <c:v>0.006973836</c:v>
                </c:pt>
                <c:pt idx="14">
                  <c:v>0.005848847</c:v>
                </c:pt>
                <c:pt idx="15">
                  <c:v>0.005117059</c:v>
                </c:pt>
                <c:pt idx="16">
                  <c:v>0.004510876</c:v>
                </c:pt>
                <c:pt idx="17">
                  <c:v>0.004112215</c:v>
                </c:pt>
                <c:pt idx="18">
                  <c:v>0.003648021</c:v>
                </c:pt>
                <c:pt idx="19">
                  <c:v>0.003047299</c:v>
                </c:pt>
                <c:pt idx="20">
                  <c:v>0.002888927</c:v>
                </c:pt>
                <c:pt idx="21">
                  <c:v>0.002517571</c:v>
                </c:pt>
                <c:pt idx="22">
                  <c:v>0.002430193</c:v>
                </c:pt>
                <c:pt idx="23">
                  <c:v>0.00211891</c:v>
                </c:pt>
                <c:pt idx="24">
                  <c:v>0.001905927</c:v>
                </c:pt>
                <c:pt idx="25">
                  <c:v>0.001884083</c:v>
                </c:pt>
                <c:pt idx="26">
                  <c:v>0.001534572</c:v>
                </c:pt>
                <c:pt idx="27">
                  <c:v>0.001485422</c:v>
                </c:pt>
                <c:pt idx="28">
                  <c:v>0.001485422</c:v>
                </c:pt>
                <c:pt idx="29">
                  <c:v>0.001086761</c:v>
                </c:pt>
                <c:pt idx="30">
                  <c:v>0.001108605</c:v>
                </c:pt>
                <c:pt idx="31">
                  <c:v>0.001141372</c:v>
                </c:pt>
                <c:pt idx="32">
                  <c:v>0.000977538</c:v>
                </c:pt>
                <c:pt idx="33">
                  <c:v>0.000890161</c:v>
                </c:pt>
                <c:pt idx="34">
                  <c:v>0.000841011</c:v>
                </c:pt>
                <c:pt idx="35">
                  <c:v>0.000813705</c:v>
                </c:pt>
                <c:pt idx="36">
                  <c:v>0.000726327</c:v>
                </c:pt>
                <c:pt idx="37">
                  <c:v>0.000709944</c:v>
                </c:pt>
                <c:pt idx="38">
                  <c:v>0.000720866</c:v>
                </c:pt>
                <c:pt idx="39">
                  <c:v>0.0006334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-2144311872"/>
        <c:axId val="-2144305952"/>
      </c:barChart>
      <c:catAx>
        <c:axId val="-2144311872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Gap(bp)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-2144305952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-21443059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Density</a:t>
                </a:r>
                <a:endParaRPr 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-21443118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 b="0">
          <a:latin typeface="Arial" charset="0"/>
          <a:ea typeface="Arial" charset="0"/>
          <a:cs typeface="Arial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783544914029"/>
          <c:y val="0.235910184817402"/>
          <c:w val="0.607327800241186"/>
          <c:h val="0.5136035904449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450K.island.gap'!$A$2</c:f>
              <c:strCache>
                <c:ptCount val="1"/>
                <c:pt idx="0">
                  <c:v>Fraction</c:v>
                </c:pt>
              </c:strCache>
            </c:strRef>
          </c:tx>
          <c:spPr>
            <a:solidFill>
              <a:srgbClr val="1545AD"/>
            </a:solidFill>
            <a:ln w="3175">
              <a:solidFill>
                <a:schemeClr val="bg1">
                  <a:lumMod val="85000"/>
                  <a:alpha val="51000"/>
                </a:schemeClr>
              </a:solidFill>
            </a:ln>
            <a:effectLst/>
          </c:spPr>
          <c:invertIfNegative val="0"/>
          <c:cat>
            <c:numRef>
              <c:f>'450K.island.gap'!$B$3:$AO$3</c:f>
              <c:numCache>
                <c:formatCode>General</c:formatCode>
                <c:ptCount val="40"/>
                <c:pt idx="0">
                  <c:v>0.0</c:v>
                </c:pt>
                <c:pt idx="1">
                  <c:v>200.0</c:v>
                </c:pt>
                <c:pt idx="2">
                  <c:v>300.0</c:v>
                </c:pt>
                <c:pt idx="3">
                  <c:v>400.0</c:v>
                </c:pt>
                <c:pt idx="4">
                  <c:v>500.0</c:v>
                </c:pt>
                <c:pt idx="5">
                  <c:v>600.0</c:v>
                </c:pt>
                <c:pt idx="6">
                  <c:v>700.0</c:v>
                </c:pt>
                <c:pt idx="7">
                  <c:v>800.0</c:v>
                </c:pt>
                <c:pt idx="8">
                  <c:v>900.0</c:v>
                </c:pt>
                <c:pt idx="9">
                  <c:v>1000.0</c:v>
                </c:pt>
                <c:pt idx="10">
                  <c:v>1000.0</c:v>
                </c:pt>
                <c:pt idx="11">
                  <c:v>1200.0</c:v>
                </c:pt>
                <c:pt idx="12">
                  <c:v>1300.0</c:v>
                </c:pt>
                <c:pt idx="13">
                  <c:v>1400.0</c:v>
                </c:pt>
                <c:pt idx="14">
                  <c:v>1500.0</c:v>
                </c:pt>
                <c:pt idx="15">
                  <c:v>1600.0</c:v>
                </c:pt>
                <c:pt idx="16">
                  <c:v>1700.0</c:v>
                </c:pt>
                <c:pt idx="17">
                  <c:v>1800.0</c:v>
                </c:pt>
                <c:pt idx="18">
                  <c:v>1900.0</c:v>
                </c:pt>
                <c:pt idx="19">
                  <c:v>2000.0</c:v>
                </c:pt>
                <c:pt idx="20">
                  <c:v>2000.0</c:v>
                </c:pt>
                <c:pt idx="21">
                  <c:v>2200.0</c:v>
                </c:pt>
                <c:pt idx="22">
                  <c:v>2300.0</c:v>
                </c:pt>
                <c:pt idx="23">
                  <c:v>2400.0</c:v>
                </c:pt>
                <c:pt idx="24">
                  <c:v>2500.0</c:v>
                </c:pt>
                <c:pt idx="25">
                  <c:v>2600.0</c:v>
                </c:pt>
                <c:pt idx="26">
                  <c:v>2700.0</c:v>
                </c:pt>
                <c:pt idx="27">
                  <c:v>2800.0</c:v>
                </c:pt>
                <c:pt idx="28">
                  <c:v>2900.0</c:v>
                </c:pt>
                <c:pt idx="29">
                  <c:v>3000.0</c:v>
                </c:pt>
                <c:pt idx="30">
                  <c:v>3000.0</c:v>
                </c:pt>
                <c:pt idx="31">
                  <c:v>3200.0</c:v>
                </c:pt>
                <c:pt idx="32">
                  <c:v>3300.0</c:v>
                </c:pt>
                <c:pt idx="33">
                  <c:v>3400.0</c:v>
                </c:pt>
                <c:pt idx="34">
                  <c:v>3500.0</c:v>
                </c:pt>
                <c:pt idx="35">
                  <c:v>3600.0</c:v>
                </c:pt>
                <c:pt idx="36">
                  <c:v>3700.0</c:v>
                </c:pt>
                <c:pt idx="37">
                  <c:v>3800.0</c:v>
                </c:pt>
                <c:pt idx="38">
                  <c:v>3900.0</c:v>
                </c:pt>
                <c:pt idx="39">
                  <c:v>4000.0</c:v>
                </c:pt>
              </c:numCache>
            </c:numRef>
          </c:cat>
          <c:val>
            <c:numRef>
              <c:f>'450K.island.gap'!$B$4:$AO$4</c:f>
              <c:numCache>
                <c:formatCode>General</c:formatCode>
                <c:ptCount val="40"/>
                <c:pt idx="0">
                  <c:v>0.459973252157576</c:v>
                </c:pt>
                <c:pt idx="1">
                  <c:v>0.188522092068512</c:v>
                </c:pt>
                <c:pt idx="2">
                  <c:v>0.103947278783511</c:v>
                </c:pt>
                <c:pt idx="3">
                  <c:v>0.0654640894080695</c:v>
                </c:pt>
                <c:pt idx="4">
                  <c:v>0.043008092477259</c:v>
                </c:pt>
                <c:pt idx="5">
                  <c:v>0.0305269611797735</c:v>
                </c:pt>
                <c:pt idx="6">
                  <c:v>0.0217317255943865</c:v>
                </c:pt>
                <c:pt idx="7">
                  <c:v>0.0162136385312351</c:v>
                </c:pt>
                <c:pt idx="8">
                  <c:v>0.012739287417399</c:v>
                </c:pt>
                <c:pt idx="9">
                  <c:v>0.0102150942449113</c:v>
                </c:pt>
                <c:pt idx="10">
                  <c:v>0.00811757577061395</c:v>
                </c:pt>
                <c:pt idx="11">
                  <c:v>0.00714231931760732</c:v>
                </c:pt>
                <c:pt idx="12">
                  <c:v>0.00571528965475204</c:v>
                </c:pt>
                <c:pt idx="13">
                  <c:v>0.0050125313283208</c:v>
                </c:pt>
                <c:pt idx="14">
                  <c:v>0.00414125442361268</c:v>
                </c:pt>
                <c:pt idx="15">
                  <c:v>0.00377911875540066</c:v>
                </c:pt>
                <c:pt idx="16">
                  <c:v>0.00319826748559525</c:v>
                </c:pt>
                <c:pt idx="17">
                  <c:v>0.00278952029573218</c:v>
                </c:pt>
                <c:pt idx="18">
                  <c:v>0.0023090630725598</c:v>
                </c:pt>
                <c:pt idx="19">
                  <c:v>0.00225528054757781</c:v>
                </c:pt>
                <c:pt idx="20">
                  <c:v>0.00143420066618621</c:v>
                </c:pt>
                <c:pt idx="21">
                  <c:v>0.00082466538305707</c:v>
                </c:pt>
                <c:pt idx="22">
                  <c:v>0.000394405183201208</c:v>
                </c:pt>
                <c:pt idx="23">
                  <c:v>0.000215130099927931</c:v>
                </c:pt>
                <c:pt idx="24" formatCode="0.00E+00">
                  <c:v>7.88810366402415E-5</c:v>
                </c:pt>
                <c:pt idx="25" formatCode="0.00E+00">
                  <c:v>4.66115216510518E-5</c:v>
                </c:pt>
                <c:pt idx="26" formatCode="0.00E+00">
                  <c:v>3.58550166546552E-5</c:v>
                </c:pt>
                <c:pt idx="27" formatCode="0.00E+00">
                  <c:v>3.94405183201208E-5</c:v>
                </c:pt>
                <c:pt idx="28" formatCode="0.00E+00">
                  <c:v>2.15130099927931E-5</c:v>
                </c:pt>
                <c:pt idx="29" formatCode="0.00E+00">
                  <c:v>1.07565049963966E-5</c:v>
                </c:pt>
                <c:pt idx="30" formatCode="0.00E+00">
                  <c:v>2.50985116582587E-5</c:v>
                </c:pt>
                <c:pt idx="31" formatCode="0.00E+00">
                  <c:v>1.07565049963966E-5</c:v>
                </c:pt>
                <c:pt idx="32" formatCode="0.00E+00">
                  <c:v>1.79275083273276E-5</c:v>
                </c:pt>
                <c:pt idx="33" formatCode="0.00E+00">
                  <c:v>7.17100333093105E-6</c:v>
                </c:pt>
                <c:pt idx="34" formatCode="0.00E+00">
                  <c:v>3.58550166546552E-6</c:v>
                </c:pt>
                <c:pt idx="35" formatCode="0.00E+00">
                  <c:v>3.58550166546552E-6</c:v>
                </c:pt>
                <c:pt idx="36" formatCode="0.00E+00">
                  <c:v>1.43420066618621E-5</c:v>
                </c:pt>
                <c:pt idx="37" formatCode="0.00E+00">
                  <c:v>3.58550166546552E-6</c:v>
                </c:pt>
                <c:pt idx="38" formatCode="0.00E+00">
                  <c:v>3.58550166546552E-6</c:v>
                </c:pt>
                <c:pt idx="39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-2144253008"/>
        <c:axId val="-2144246896"/>
      </c:barChart>
      <c:catAx>
        <c:axId val="-21442530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Gap(bp)</a:t>
                </a:r>
                <a:endParaRPr lang="zh-CN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-2144246896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-21442468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Density</a:t>
                </a:r>
                <a:endParaRPr lang="zh-CN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zh-CN"/>
          </a:p>
        </c:txPr>
        <c:crossAx val="-214425300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0039" y="530264"/>
            <a:ext cx="3780235" cy="1128031"/>
          </a:xfrm>
        </p:spPr>
        <p:txBody>
          <a:bodyPr anchor="b"/>
          <a:lstStyle>
            <a:lvl1pPr algn="ctr">
              <a:defRPr sz="248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1701796"/>
            <a:ext cx="3780235" cy="782271"/>
          </a:xfrm>
        </p:spPr>
        <p:txBody>
          <a:bodyPr/>
          <a:lstStyle>
            <a:lvl1pPr marL="0" indent="0" algn="ctr">
              <a:buNone/>
              <a:defRPr sz="992"/>
            </a:lvl1pPr>
            <a:lvl2pPr marL="189006" indent="0" algn="ctr">
              <a:buNone/>
              <a:defRPr sz="827"/>
            </a:lvl2pPr>
            <a:lvl3pPr marL="378013" indent="0" algn="ctr">
              <a:buNone/>
              <a:defRPr sz="744"/>
            </a:lvl3pPr>
            <a:lvl4pPr marL="567019" indent="0" algn="ctr">
              <a:buNone/>
              <a:defRPr sz="661"/>
            </a:lvl4pPr>
            <a:lvl5pPr marL="756026" indent="0" algn="ctr">
              <a:buNone/>
              <a:defRPr sz="661"/>
            </a:lvl5pPr>
            <a:lvl6pPr marL="945032" indent="0" algn="ctr">
              <a:buNone/>
              <a:defRPr sz="661"/>
            </a:lvl6pPr>
            <a:lvl7pPr marL="1134039" indent="0" algn="ctr">
              <a:buNone/>
              <a:defRPr sz="661"/>
            </a:lvl7pPr>
            <a:lvl8pPr marL="1323045" indent="0" algn="ctr">
              <a:buNone/>
              <a:defRPr sz="661"/>
            </a:lvl8pPr>
            <a:lvl9pPr marL="1512052" indent="0" algn="ctr">
              <a:buNone/>
              <a:defRPr sz="661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04614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9623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4" y="172505"/>
            <a:ext cx="1086817" cy="27458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1" y="172505"/>
            <a:ext cx="3197449" cy="27458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26311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42069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6" y="807773"/>
            <a:ext cx="4347270" cy="1347786"/>
          </a:xfrm>
        </p:spPr>
        <p:txBody>
          <a:bodyPr anchor="b"/>
          <a:lstStyle>
            <a:lvl1pPr>
              <a:defRPr sz="248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6" y="2168309"/>
            <a:ext cx="4347270" cy="708769"/>
          </a:xfrm>
        </p:spPr>
        <p:txBody>
          <a:bodyPr/>
          <a:lstStyle>
            <a:lvl1pPr marL="0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1pPr>
            <a:lvl2pPr marL="189006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2pPr>
            <a:lvl3pPr marL="378013" indent="0">
              <a:buNone/>
              <a:defRPr sz="744">
                <a:solidFill>
                  <a:schemeClr val="tx1">
                    <a:tint val="75000"/>
                  </a:schemeClr>
                </a:solidFill>
              </a:defRPr>
            </a:lvl3pPr>
            <a:lvl4pPr marL="567019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4pPr>
            <a:lvl5pPr marL="756026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5pPr>
            <a:lvl6pPr marL="945032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6pPr>
            <a:lvl7pPr marL="1134039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7pPr>
            <a:lvl8pPr marL="1323045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8pPr>
            <a:lvl9pPr marL="1512052" indent="0">
              <a:buNone/>
              <a:defRPr sz="66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5440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862523"/>
            <a:ext cx="2142133" cy="205580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862523"/>
            <a:ext cx="2142133" cy="205580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35825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172505"/>
            <a:ext cx="4347270" cy="62626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8" y="794272"/>
            <a:ext cx="2132288" cy="389260"/>
          </a:xfrm>
        </p:spPr>
        <p:txBody>
          <a:bodyPr anchor="b"/>
          <a:lstStyle>
            <a:lvl1pPr marL="0" indent="0">
              <a:buNone/>
              <a:defRPr sz="992" b="1"/>
            </a:lvl1pPr>
            <a:lvl2pPr marL="189006" indent="0">
              <a:buNone/>
              <a:defRPr sz="827" b="1"/>
            </a:lvl2pPr>
            <a:lvl3pPr marL="378013" indent="0">
              <a:buNone/>
              <a:defRPr sz="744" b="1"/>
            </a:lvl3pPr>
            <a:lvl4pPr marL="567019" indent="0">
              <a:buNone/>
              <a:defRPr sz="661" b="1"/>
            </a:lvl4pPr>
            <a:lvl5pPr marL="756026" indent="0">
              <a:buNone/>
              <a:defRPr sz="661" b="1"/>
            </a:lvl5pPr>
            <a:lvl6pPr marL="945032" indent="0">
              <a:buNone/>
              <a:defRPr sz="661" b="1"/>
            </a:lvl6pPr>
            <a:lvl7pPr marL="1134039" indent="0">
              <a:buNone/>
              <a:defRPr sz="661" b="1"/>
            </a:lvl7pPr>
            <a:lvl8pPr marL="1323045" indent="0">
              <a:buNone/>
              <a:defRPr sz="661" b="1"/>
            </a:lvl8pPr>
            <a:lvl9pPr marL="1512052" indent="0">
              <a:buNone/>
              <a:defRPr sz="661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8" y="1183532"/>
            <a:ext cx="2132288" cy="1740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794272"/>
            <a:ext cx="2142790" cy="389260"/>
          </a:xfrm>
        </p:spPr>
        <p:txBody>
          <a:bodyPr anchor="b"/>
          <a:lstStyle>
            <a:lvl1pPr marL="0" indent="0">
              <a:buNone/>
              <a:defRPr sz="992" b="1"/>
            </a:lvl1pPr>
            <a:lvl2pPr marL="189006" indent="0">
              <a:buNone/>
              <a:defRPr sz="827" b="1"/>
            </a:lvl2pPr>
            <a:lvl3pPr marL="378013" indent="0">
              <a:buNone/>
              <a:defRPr sz="744" b="1"/>
            </a:lvl3pPr>
            <a:lvl4pPr marL="567019" indent="0">
              <a:buNone/>
              <a:defRPr sz="661" b="1"/>
            </a:lvl4pPr>
            <a:lvl5pPr marL="756026" indent="0">
              <a:buNone/>
              <a:defRPr sz="661" b="1"/>
            </a:lvl5pPr>
            <a:lvl6pPr marL="945032" indent="0">
              <a:buNone/>
              <a:defRPr sz="661" b="1"/>
            </a:lvl6pPr>
            <a:lvl7pPr marL="1134039" indent="0">
              <a:buNone/>
              <a:defRPr sz="661" b="1"/>
            </a:lvl7pPr>
            <a:lvl8pPr marL="1323045" indent="0">
              <a:buNone/>
              <a:defRPr sz="661" b="1"/>
            </a:lvl8pPr>
            <a:lvl9pPr marL="1512052" indent="0">
              <a:buNone/>
              <a:defRPr sz="661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1183532"/>
            <a:ext cx="2142790" cy="1740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6734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49825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69505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216006"/>
            <a:ext cx="1625632" cy="756021"/>
          </a:xfrm>
        </p:spPr>
        <p:txBody>
          <a:bodyPr anchor="b"/>
          <a:lstStyle>
            <a:lvl1pPr>
              <a:defRPr sz="132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466513"/>
            <a:ext cx="2551658" cy="2302563"/>
          </a:xfrm>
        </p:spPr>
        <p:txBody>
          <a:bodyPr/>
          <a:lstStyle>
            <a:lvl1pPr>
              <a:defRPr sz="1323"/>
            </a:lvl1pPr>
            <a:lvl2pPr>
              <a:defRPr sz="1158"/>
            </a:lvl2pPr>
            <a:lvl3pPr>
              <a:defRPr sz="992"/>
            </a:lvl3pPr>
            <a:lvl4pPr>
              <a:defRPr sz="827"/>
            </a:lvl4pPr>
            <a:lvl5pPr>
              <a:defRPr sz="827"/>
            </a:lvl5pPr>
            <a:lvl6pPr>
              <a:defRPr sz="827"/>
            </a:lvl6pPr>
            <a:lvl7pPr>
              <a:defRPr sz="827"/>
            </a:lvl7pPr>
            <a:lvl8pPr>
              <a:defRPr sz="827"/>
            </a:lvl8pPr>
            <a:lvl9pPr>
              <a:defRPr sz="827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972026"/>
            <a:ext cx="1625632" cy="1800799"/>
          </a:xfrm>
        </p:spPr>
        <p:txBody>
          <a:bodyPr/>
          <a:lstStyle>
            <a:lvl1pPr marL="0" indent="0">
              <a:buNone/>
              <a:defRPr sz="661"/>
            </a:lvl1pPr>
            <a:lvl2pPr marL="189006" indent="0">
              <a:buNone/>
              <a:defRPr sz="579"/>
            </a:lvl2pPr>
            <a:lvl3pPr marL="378013" indent="0">
              <a:buNone/>
              <a:defRPr sz="496"/>
            </a:lvl3pPr>
            <a:lvl4pPr marL="567019" indent="0">
              <a:buNone/>
              <a:defRPr sz="413"/>
            </a:lvl4pPr>
            <a:lvl5pPr marL="756026" indent="0">
              <a:buNone/>
              <a:defRPr sz="413"/>
            </a:lvl5pPr>
            <a:lvl6pPr marL="945032" indent="0">
              <a:buNone/>
              <a:defRPr sz="413"/>
            </a:lvl6pPr>
            <a:lvl7pPr marL="1134039" indent="0">
              <a:buNone/>
              <a:defRPr sz="413"/>
            </a:lvl7pPr>
            <a:lvl8pPr marL="1323045" indent="0">
              <a:buNone/>
              <a:defRPr sz="413"/>
            </a:lvl8pPr>
            <a:lvl9pPr marL="1512052" indent="0">
              <a:buNone/>
              <a:defRPr sz="41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4060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216006"/>
            <a:ext cx="1625632" cy="756021"/>
          </a:xfrm>
        </p:spPr>
        <p:txBody>
          <a:bodyPr anchor="b"/>
          <a:lstStyle>
            <a:lvl1pPr>
              <a:defRPr sz="132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466513"/>
            <a:ext cx="2551658" cy="2302563"/>
          </a:xfrm>
        </p:spPr>
        <p:txBody>
          <a:bodyPr anchor="t"/>
          <a:lstStyle>
            <a:lvl1pPr marL="0" indent="0">
              <a:buNone/>
              <a:defRPr sz="1323"/>
            </a:lvl1pPr>
            <a:lvl2pPr marL="189006" indent="0">
              <a:buNone/>
              <a:defRPr sz="1158"/>
            </a:lvl2pPr>
            <a:lvl3pPr marL="378013" indent="0">
              <a:buNone/>
              <a:defRPr sz="992"/>
            </a:lvl3pPr>
            <a:lvl4pPr marL="567019" indent="0">
              <a:buNone/>
              <a:defRPr sz="827"/>
            </a:lvl4pPr>
            <a:lvl5pPr marL="756026" indent="0">
              <a:buNone/>
              <a:defRPr sz="827"/>
            </a:lvl5pPr>
            <a:lvl6pPr marL="945032" indent="0">
              <a:buNone/>
              <a:defRPr sz="827"/>
            </a:lvl6pPr>
            <a:lvl7pPr marL="1134039" indent="0">
              <a:buNone/>
              <a:defRPr sz="827"/>
            </a:lvl7pPr>
            <a:lvl8pPr marL="1323045" indent="0">
              <a:buNone/>
              <a:defRPr sz="827"/>
            </a:lvl8pPr>
            <a:lvl9pPr marL="1512052" indent="0">
              <a:buNone/>
              <a:defRPr sz="827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972026"/>
            <a:ext cx="1625632" cy="1800799"/>
          </a:xfrm>
        </p:spPr>
        <p:txBody>
          <a:bodyPr/>
          <a:lstStyle>
            <a:lvl1pPr marL="0" indent="0">
              <a:buNone/>
              <a:defRPr sz="661"/>
            </a:lvl1pPr>
            <a:lvl2pPr marL="189006" indent="0">
              <a:buNone/>
              <a:defRPr sz="579"/>
            </a:lvl2pPr>
            <a:lvl3pPr marL="378013" indent="0">
              <a:buNone/>
              <a:defRPr sz="496"/>
            </a:lvl3pPr>
            <a:lvl4pPr marL="567019" indent="0">
              <a:buNone/>
              <a:defRPr sz="413"/>
            </a:lvl4pPr>
            <a:lvl5pPr marL="756026" indent="0">
              <a:buNone/>
              <a:defRPr sz="413"/>
            </a:lvl5pPr>
            <a:lvl6pPr marL="945032" indent="0">
              <a:buNone/>
              <a:defRPr sz="413"/>
            </a:lvl6pPr>
            <a:lvl7pPr marL="1134039" indent="0">
              <a:buNone/>
              <a:defRPr sz="413"/>
            </a:lvl7pPr>
            <a:lvl8pPr marL="1323045" indent="0">
              <a:buNone/>
              <a:defRPr sz="413"/>
            </a:lvl8pPr>
            <a:lvl9pPr marL="1512052" indent="0">
              <a:buNone/>
              <a:defRPr sz="41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7039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172505"/>
            <a:ext cx="4347270" cy="6262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862523"/>
            <a:ext cx="4347270" cy="20558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3003082"/>
            <a:ext cx="1134070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AB434-05C0-6345-9D5D-6D7A51ED68F9}" type="datetimeFigureOut">
              <a:rPr kumimoji="1" lang="zh-CN" altLang="en-US" smtClean="0"/>
              <a:t>2018/9/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3003082"/>
            <a:ext cx="1701106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3003082"/>
            <a:ext cx="1134070" cy="172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D45B68-76DA-864D-B898-A784E7AC71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548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78013" rtl="0" eaLnBrk="1" latinLnBrk="0" hangingPunct="1">
        <a:lnSpc>
          <a:spcPct val="90000"/>
        </a:lnSpc>
        <a:spcBef>
          <a:spcPct val="0"/>
        </a:spcBef>
        <a:buNone/>
        <a:defRPr sz="18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4503" indent="-94503" algn="l" defTabSz="378013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158" kern="1200">
          <a:solidFill>
            <a:schemeClr val="tx1"/>
          </a:solidFill>
          <a:latin typeface="+mn-lt"/>
          <a:ea typeface="+mn-ea"/>
          <a:cs typeface="+mn-cs"/>
        </a:defRPr>
      </a:lvl1pPr>
      <a:lvl2pPr marL="283510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472516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827" kern="1200">
          <a:solidFill>
            <a:schemeClr val="tx1"/>
          </a:solidFill>
          <a:latin typeface="+mn-lt"/>
          <a:ea typeface="+mn-ea"/>
          <a:cs typeface="+mn-cs"/>
        </a:defRPr>
      </a:lvl3pPr>
      <a:lvl4pPr marL="661523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4pPr>
      <a:lvl5pPr marL="850529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5pPr>
      <a:lvl6pPr marL="1039536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6pPr>
      <a:lvl7pPr marL="1228542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7pPr>
      <a:lvl8pPr marL="1417549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8pPr>
      <a:lvl9pPr marL="1606555" indent="-94503" algn="l" defTabSz="378013" rtl="0" eaLnBrk="1" latinLnBrk="0" hangingPunct="1">
        <a:lnSpc>
          <a:spcPct val="90000"/>
        </a:lnSpc>
        <a:spcBef>
          <a:spcPts val="207"/>
        </a:spcBef>
        <a:buFont typeface="Arial" panose="020B0604020202020204" pitchFamily="34" charset="0"/>
        <a:buChar char="•"/>
        <a:defRPr sz="7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1pPr>
      <a:lvl2pPr marL="189006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2pPr>
      <a:lvl3pPr marL="378013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3pPr>
      <a:lvl4pPr marL="567019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4pPr>
      <a:lvl5pPr marL="756026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5pPr>
      <a:lvl6pPr marL="945032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6pPr>
      <a:lvl7pPr marL="1134039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7pPr>
      <a:lvl8pPr marL="1323045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8pPr>
      <a:lvl9pPr marL="1512052" algn="l" defTabSz="378013" rtl="0" eaLnBrk="1" latinLnBrk="0" hangingPunct="1">
        <a:defRPr sz="7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5589501"/>
              </p:ext>
            </p:extLst>
          </p:nvPr>
        </p:nvGraphicFramePr>
        <p:xfrm>
          <a:off x="2220913" y="1624779"/>
          <a:ext cx="2819400" cy="1618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0762950"/>
              </p:ext>
            </p:extLst>
          </p:nvPr>
        </p:nvGraphicFramePr>
        <p:xfrm>
          <a:off x="61916" y="1597462"/>
          <a:ext cx="2701131" cy="16564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6000569"/>
              </p:ext>
            </p:extLst>
          </p:nvPr>
        </p:nvGraphicFramePr>
        <p:xfrm>
          <a:off x="2220913" y="0"/>
          <a:ext cx="2819400" cy="15746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934245" y="37820"/>
            <a:ext cx="1286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HM450K</a:t>
            </a:r>
          </a:p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In CpG islands</a:t>
            </a:r>
            <a:endParaRPr kumimoji="1" lang="zh-CN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235161" y="50146"/>
            <a:ext cx="1286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HM450K </a:t>
            </a:r>
          </a:p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Out of  CpG islands</a:t>
            </a:r>
            <a:endParaRPr kumimoji="1" lang="zh-CN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34245" y="1643942"/>
            <a:ext cx="1286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EPIC</a:t>
            </a:r>
          </a:p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In CpG islands</a:t>
            </a:r>
            <a:endParaRPr kumimoji="1" lang="zh-CN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58344" y="1668602"/>
            <a:ext cx="1286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EPIC</a:t>
            </a:r>
          </a:p>
          <a:p>
            <a:r>
              <a:rPr kumimoji="1" lang="en-US" altLang="zh-CN" sz="1000" dirty="0">
                <a:latin typeface="Arial" charset="0"/>
                <a:ea typeface="Arial" charset="0"/>
                <a:cs typeface="Arial" charset="0"/>
              </a:rPr>
              <a:t>Out of  CpG islands</a:t>
            </a:r>
            <a:endParaRPr kumimoji="1" lang="zh-CN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1" name="图表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1941353"/>
              </p:ext>
            </p:extLst>
          </p:nvPr>
        </p:nvGraphicFramePr>
        <p:xfrm>
          <a:off x="-43655" y="-276653"/>
          <a:ext cx="2819400" cy="1882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2" name="直线连接符 11"/>
          <p:cNvCxnSpPr/>
          <p:nvPr/>
        </p:nvCxnSpPr>
        <p:spPr>
          <a:xfrm flipV="1">
            <a:off x="536576" y="1624782"/>
            <a:ext cx="4343400" cy="10717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19051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0</Words>
  <Application>Microsoft Macintosh PowerPoint</Application>
  <PresentationFormat>自定义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宋体</vt:lpstr>
      <vt:lpstr>Arial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9</cp:revision>
  <dcterms:created xsi:type="dcterms:W3CDTF">2018-02-12T02:01:52Z</dcterms:created>
  <dcterms:modified xsi:type="dcterms:W3CDTF">2018-09-08T19:15:38Z</dcterms:modified>
</cp:coreProperties>
</file>